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DC5B4-2651-4DE2-B913-DEF9580CC5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1D206C-EA9D-4A95-9F86-750E980AF9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49C47-900D-4309-93EA-DFC7D9CF4C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FF230-1C75-43A1-AA93-25F1514B83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EFC91-9D70-4BEA-8877-3D2DCBAB6A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A71D6A-B6D4-4B5B-B897-1CF26F5870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1AA27-36C8-419F-8B1D-3DA46A4CF3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67D5C6-1E84-4C22-8BD1-7C5E9CBAA0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A99808-6FF5-4D68-A984-8CF0F6F6AC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55D38-1572-4D4A-96D3-68A011BF42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EF42F2-2399-4484-A9B3-871C1C4028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242739-8F31-4CCE-B42E-EB9DD428A9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CB89C8-33B1-40C2-A819-8CDFED3A79F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7"/>
          <p:cNvSpPr/>
          <p:nvPr/>
        </p:nvSpPr>
        <p:spPr>
          <a:xfrm>
            <a:off x="333360" y="720720"/>
            <a:ext cx="4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8"/>
          <p:cNvSpPr/>
          <p:nvPr/>
        </p:nvSpPr>
        <p:spPr>
          <a:xfrm>
            <a:off x="339840" y="2454120"/>
            <a:ext cx="4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90"/>
          <p:cNvGrpSpPr/>
          <p:nvPr/>
        </p:nvGrpSpPr>
        <p:grpSpPr>
          <a:xfrm>
            <a:off x="453960" y="1015920"/>
            <a:ext cx="3451680" cy="1132200"/>
            <a:chOff x="453960" y="1015920"/>
            <a:chExt cx="3451680" cy="1132200"/>
          </a:xfrm>
        </p:grpSpPr>
        <p:sp>
          <p:nvSpPr>
            <p:cNvPr id="44" name="Text Box 5"/>
            <p:cNvSpPr/>
            <p:nvPr/>
          </p:nvSpPr>
          <p:spPr>
            <a:xfrm>
              <a:off x="453960" y="1695600"/>
              <a:ext cx="71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m-calpa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6"/>
            <p:cNvSpPr/>
            <p:nvPr/>
          </p:nvSpPr>
          <p:spPr>
            <a:xfrm>
              <a:off x="533520" y="1901880"/>
              <a:ext cx="653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11"/>
            <p:cNvSpPr/>
            <p:nvPr/>
          </p:nvSpPr>
          <p:spPr>
            <a:xfrm>
              <a:off x="1231920" y="1206360"/>
              <a:ext cx="674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2"/>
            <p:cNvSpPr/>
            <p:nvPr/>
          </p:nvSpPr>
          <p:spPr>
            <a:xfrm>
              <a:off x="1246320" y="1015920"/>
              <a:ext cx="742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WPE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3"/>
            <p:cNvSpPr/>
            <p:nvPr/>
          </p:nvSpPr>
          <p:spPr>
            <a:xfrm rot="10800000">
              <a:off x="1083960" y="1182600"/>
              <a:ext cx="332640" cy="573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un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4"/>
            <p:cNvSpPr/>
            <p:nvPr/>
          </p:nvSpPr>
          <p:spPr>
            <a:xfrm rot="10800000">
              <a:off x="1287000" y="1271160"/>
              <a:ext cx="332640" cy="49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EG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5"/>
            <p:cNvSpPr/>
            <p:nvPr/>
          </p:nvSpPr>
          <p:spPr>
            <a:xfrm rot="10800000">
              <a:off x="1512360" y="1141560"/>
              <a:ext cx="332640" cy="622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XCL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6"/>
            <p:cNvSpPr/>
            <p:nvPr/>
          </p:nvSpPr>
          <p:spPr>
            <a:xfrm rot="10800000">
              <a:off x="1719000" y="1141560"/>
              <a:ext cx="332640" cy="620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XCL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44"/>
            <p:cNvSpPr/>
            <p:nvPr/>
          </p:nvSpPr>
          <p:spPr>
            <a:xfrm>
              <a:off x="2114640" y="1206360"/>
              <a:ext cx="674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45"/>
            <p:cNvSpPr/>
            <p:nvPr/>
          </p:nvSpPr>
          <p:spPr>
            <a:xfrm>
              <a:off x="2128680" y="1015920"/>
              <a:ext cx="743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 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U-14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46"/>
            <p:cNvSpPr/>
            <p:nvPr/>
          </p:nvSpPr>
          <p:spPr>
            <a:xfrm rot="10800000">
              <a:off x="1966680" y="1182600"/>
              <a:ext cx="332640" cy="573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un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47"/>
            <p:cNvSpPr/>
            <p:nvPr/>
          </p:nvSpPr>
          <p:spPr>
            <a:xfrm rot="10800000">
              <a:off x="2395080" y="1141560"/>
              <a:ext cx="332640" cy="622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XCL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48"/>
            <p:cNvSpPr/>
            <p:nvPr/>
          </p:nvSpPr>
          <p:spPr>
            <a:xfrm rot="10800000">
              <a:off x="2602080" y="1141560"/>
              <a:ext cx="332640" cy="620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XCL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49"/>
            <p:cNvSpPr/>
            <p:nvPr/>
          </p:nvSpPr>
          <p:spPr>
            <a:xfrm rot="10800000">
              <a:off x="2157120" y="1271160"/>
              <a:ext cx="332640" cy="49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EG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50"/>
            <p:cNvSpPr/>
            <p:nvPr/>
          </p:nvSpPr>
          <p:spPr>
            <a:xfrm>
              <a:off x="3073320" y="1206360"/>
              <a:ext cx="674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51"/>
            <p:cNvSpPr/>
            <p:nvPr/>
          </p:nvSpPr>
          <p:spPr>
            <a:xfrm>
              <a:off x="3087720" y="1015920"/>
              <a:ext cx="743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   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PC-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52"/>
            <p:cNvSpPr/>
            <p:nvPr/>
          </p:nvSpPr>
          <p:spPr>
            <a:xfrm rot="10800000">
              <a:off x="2925360" y="1182600"/>
              <a:ext cx="332640" cy="573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untre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53"/>
            <p:cNvSpPr/>
            <p:nvPr/>
          </p:nvSpPr>
          <p:spPr>
            <a:xfrm rot="10800000">
              <a:off x="3366720" y="1141560"/>
              <a:ext cx="332640" cy="622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XCL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54"/>
            <p:cNvSpPr/>
            <p:nvPr/>
          </p:nvSpPr>
          <p:spPr>
            <a:xfrm rot="10800000">
              <a:off x="3573000" y="1141560"/>
              <a:ext cx="332640" cy="620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XCL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55"/>
            <p:cNvSpPr/>
            <p:nvPr/>
          </p:nvSpPr>
          <p:spPr>
            <a:xfrm rot="10800000">
              <a:off x="3153960" y="1271160"/>
              <a:ext cx="332640" cy="49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EG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4" name="Picture 62" descr="2010_5_25_mcalpain_Part2_PC3GAPDH_crop"/>
            <p:cNvPicPr/>
            <p:nvPr/>
          </p:nvPicPr>
          <p:blipFill>
            <a:blip r:embed="rId1"/>
            <a:stretch/>
          </p:blipFill>
          <p:spPr>
            <a:xfrm>
              <a:off x="2981160" y="1928880"/>
              <a:ext cx="914400" cy="18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63" descr="2010_5_25_mcalpain_Part2_DUBOXmCal_crop"/>
            <p:cNvPicPr/>
            <p:nvPr/>
          </p:nvPicPr>
          <p:blipFill>
            <a:blip r:embed="rId2"/>
            <a:stretch/>
          </p:blipFill>
          <p:spPr>
            <a:xfrm>
              <a:off x="2976480" y="1728720"/>
              <a:ext cx="914400" cy="18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67" descr="2010_5_25_mcalpain_Part2_RWGAPDH_crop"/>
            <p:cNvPicPr/>
            <p:nvPr/>
          </p:nvPicPr>
          <p:blipFill>
            <a:blip r:embed="rId3"/>
            <a:stretch/>
          </p:blipFill>
          <p:spPr>
            <a:xfrm>
              <a:off x="1087560" y="1932120"/>
              <a:ext cx="914400" cy="18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68" descr="2010_5_25_mcalpain_Part2_DU1GAP_crop"/>
            <p:cNvPicPr/>
            <p:nvPr/>
          </p:nvPicPr>
          <p:blipFill>
            <a:blip r:embed="rId4"/>
            <a:stretch/>
          </p:blipFill>
          <p:spPr>
            <a:xfrm>
              <a:off x="2033640" y="1928880"/>
              <a:ext cx="914400" cy="18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69" descr="2010_5_6_mCalpain_GAPDH_afterTreatment_DUmCal_crop2"/>
            <p:cNvPicPr/>
            <p:nvPr/>
          </p:nvPicPr>
          <p:blipFill>
            <a:blip r:embed="rId5"/>
            <a:stretch/>
          </p:blipFill>
          <p:spPr>
            <a:xfrm>
              <a:off x="2028960" y="1728720"/>
              <a:ext cx="914400" cy="18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70" descr="2010_5_6_mCalpain_GAPDH_afterTreatment_RWPEmCal_crop2"/>
            <p:cNvPicPr/>
            <p:nvPr/>
          </p:nvPicPr>
          <p:blipFill>
            <a:blip r:embed="rId6"/>
            <a:stretch/>
          </p:blipFill>
          <p:spPr>
            <a:xfrm>
              <a:off x="1084320" y="1728720"/>
              <a:ext cx="914400" cy="1825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70" name="Group 89"/>
          <p:cNvGrpSpPr/>
          <p:nvPr/>
        </p:nvGrpSpPr>
        <p:grpSpPr>
          <a:xfrm>
            <a:off x="882720" y="2654280"/>
            <a:ext cx="2689200" cy="1140120"/>
            <a:chOff x="882720" y="2654280"/>
            <a:chExt cx="2689200" cy="1140120"/>
          </a:xfrm>
        </p:grpSpPr>
        <p:grpSp>
          <p:nvGrpSpPr>
            <p:cNvPr id="71" name="Group 86"/>
            <p:cNvGrpSpPr/>
            <p:nvPr/>
          </p:nvGrpSpPr>
          <p:grpSpPr>
            <a:xfrm>
              <a:off x="1533600" y="3397320"/>
              <a:ext cx="1849320" cy="390240"/>
              <a:chOff x="1533600" y="3397320"/>
              <a:chExt cx="1849320" cy="390240"/>
            </a:xfrm>
          </p:grpSpPr>
          <p:pic>
            <p:nvPicPr>
              <p:cNvPr id="72" name="Picture 61" descr="2010_5_25_mcalpain_Part2_PC3mCal_crop"/>
              <p:cNvPicPr/>
              <p:nvPr/>
            </p:nvPicPr>
            <p:blipFill>
              <a:blip r:embed="rId7"/>
              <a:stretch/>
            </p:blipFill>
            <p:spPr>
              <a:xfrm>
                <a:off x="2466720" y="3398760"/>
                <a:ext cx="914400" cy="182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3" name="Picture 64" descr="2010_5_25_mcalpain_Part2_DUmCal_crop"/>
              <p:cNvPicPr/>
              <p:nvPr/>
            </p:nvPicPr>
            <p:blipFill>
              <a:blip r:embed="rId8"/>
              <a:stretch/>
            </p:blipFill>
            <p:spPr>
              <a:xfrm>
                <a:off x="1533600" y="3397320"/>
                <a:ext cx="914400" cy="182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4" name="Picture 65" descr="2010_5_25_mcalpain_Part2_DUOXGAP_crop"/>
              <p:cNvPicPr/>
              <p:nvPr/>
            </p:nvPicPr>
            <p:blipFill>
              <a:blip r:embed="rId9"/>
              <a:stretch/>
            </p:blipFill>
            <p:spPr>
              <a:xfrm>
                <a:off x="2468520" y="3595680"/>
                <a:ext cx="914400" cy="191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5" name="Picture 66" descr="2010_5_25_mcalpain_Part2_RWPEGAP_crop"/>
              <p:cNvPicPr/>
              <p:nvPr/>
            </p:nvPicPr>
            <p:blipFill>
              <a:blip r:embed="rId10"/>
              <a:stretch/>
            </p:blipFill>
            <p:spPr>
              <a:xfrm>
                <a:off x="1536480" y="3600360"/>
                <a:ext cx="914400" cy="18252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76" name="Group 85"/>
            <p:cNvGrpSpPr/>
            <p:nvPr/>
          </p:nvGrpSpPr>
          <p:grpSpPr>
            <a:xfrm>
              <a:off x="1480680" y="2654280"/>
              <a:ext cx="2091240" cy="747360"/>
              <a:chOff x="1480680" y="2654280"/>
              <a:chExt cx="2091240" cy="747360"/>
            </a:xfrm>
          </p:grpSpPr>
          <p:sp>
            <p:nvSpPr>
              <p:cNvPr id="77" name="Line 71"/>
              <p:cNvSpPr/>
              <p:nvPr/>
            </p:nvSpPr>
            <p:spPr>
              <a:xfrm>
                <a:off x="1628640" y="2844720"/>
                <a:ext cx="674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Text Box 72"/>
              <p:cNvSpPr/>
              <p:nvPr/>
            </p:nvSpPr>
            <p:spPr>
              <a:xfrm>
                <a:off x="1643040" y="2654280"/>
                <a:ext cx="743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DU-14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 Box 73"/>
              <p:cNvSpPr/>
              <p:nvPr/>
            </p:nvSpPr>
            <p:spPr>
              <a:xfrm rot="10800000">
                <a:off x="1480680" y="2820600"/>
                <a:ext cx="332640" cy="572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untre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 Box 74"/>
              <p:cNvSpPr/>
              <p:nvPr/>
            </p:nvSpPr>
            <p:spPr>
              <a:xfrm rot="10800000">
                <a:off x="1909800" y="2779200"/>
                <a:ext cx="332640" cy="622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CXCL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 Box 75"/>
              <p:cNvSpPr/>
              <p:nvPr/>
            </p:nvSpPr>
            <p:spPr>
              <a:xfrm rot="10800000">
                <a:off x="2115720" y="2779560"/>
                <a:ext cx="332640" cy="620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CXCL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 Box 76"/>
              <p:cNvSpPr/>
              <p:nvPr/>
            </p:nvSpPr>
            <p:spPr>
              <a:xfrm rot="10800000">
                <a:off x="1671120" y="2909880"/>
                <a:ext cx="332640" cy="490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EGF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77"/>
              <p:cNvSpPr/>
              <p:nvPr/>
            </p:nvSpPr>
            <p:spPr>
              <a:xfrm>
                <a:off x="2587680" y="2844720"/>
                <a:ext cx="674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 Box 78"/>
              <p:cNvSpPr/>
              <p:nvPr/>
            </p:nvSpPr>
            <p:spPr>
              <a:xfrm>
                <a:off x="2239920" y="2654280"/>
                <a:ext cx="1332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   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DU-CXCR3BOX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Text Box 79"/>
              <p:cNvSpPr/>
              <p:nvPr/>
            </p:nvSpPr>
            <p:spPr>
              <a:xfrm rot="10800000">
                <a:off x="2439360" y="2820600"/>
                <a:ext cx="332640" cy="572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untreate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Text Box 80"/>
              <p:cNvSpPr/>
              <p:nvPr/>
            </p:nvSpPr>
            <p:spPr>
              <a:xfrm rot="10800000">
                <a:off x="2880720" y="2779200"/>
                <a:ext cx="332640" cy="622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CXCL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Text Box 81"/>
              <p:cNvSpPr/>
              <p:nvPr/>
            </p:nvSpPr>
            <p:spPr>
              <a:xfrm rot="10800000">
                <a:off x="3087720" y="2779560"/>
                <a:ext cx="332640" cy="620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CXCL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Text Box 82"/>
              <p:cNvSpPr/>
              <p:nvPr/>
            </p:nvSpPr>
            <p:spPr>
              <a:xfrm rot="10800000">
                <a:off x="2667960" y="2909880"/>
                <a:ext cx="332640" cy="490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>
                  <a:lnSpc>
                    <a:spcPct val="100000"/>
                  </a:lnSpc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EGF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9" name="Text Box 87"/>
            <p:cNvSpPr/>
            <p:nvPr/>
          </p:nvSpPr>
          <p:spPr>
            <a:xfrm>
              <a:off x="882720" y="3341520"/>
              <a:ext cx="71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m-calpa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88"/>
            <p:cNvSpPr/>
            <p:nvPr/>
          </p:nvSpPr>
          <p:spPr>
            <a:xfrm>
              <a:off x="961920" y="3548160"/>
              <a:ext cx="654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22T18:32:20Z</dcterms:created>
  <dc:creator>QianWu</dc:creator>
  <dc:description/>
  <dc:language>en-US</dc:language>
  <cp:lastModifiedBy>Qian Wu</cp:lastModifiedBy>
  <dcterms:modified xsi:type="dcterms:W3CDTF">2012-01-09T17:16:31Z</dcterms:modified>
  <cp:revision>84</cp:revision>
  <dc:subject/>
  <dc:title>Slide 1</dc:title>
</cp:coreProperties>
</file>